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4E25E6-F4E7-4780-A17F-80E07B0A21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147421-CA6E-4036-9C3A-9ABBDDDEB6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C6B20D-67D4-44F4-9D79-5245FD47898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6A298B-3383-4CA6-8FB5-93E09BA030E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7B5D35-54A7-44EB-A00F-C04173E5C6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34DA19-8BD0-41AC-A985-DB3BE7F87F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1D1064-3D03-4F76-8D82-6B5788165E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B2164A-EC73-4837-A653-5E28B5AADC7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CAD1A3-C235-49E7-931B-EF3E12B59D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22CA6E-7F2C-45F2-9C15-2153928F77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8873A0-536E-4D81-A5DC-35367BB8C7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0389B8-DB5B-4090-A108-F2479FD804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072759B-1012-45B8-83CA-0D63B8C5E09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128600" y="-111240"/>
            <a:ext cx="1843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71080" y="0"/>
            <a:ext cx="1563120" cy="82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Additional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File 11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"/>
          <p:cNvGrpSpPr/>
          <p:nvPr/>
        </p:nvGrpSpPr>
        <p:grpSpPr>
          <a:xfrm>
            <a:off x="2836800" y="380880"/>
            <a:ext cx="5199120" cy="854640"/>
            <a:chOff x="2836800" y="380880"/>
            <a:chExt cx="5199120" cy="854640"/>
          </a:xfrm>
        </p:grpSpPr>
        <p:sp>
          <p:nvSpPr>
            <p:cNvPr id="44" name=""/>
            <p:cNvSpPr/>
            <p:nvPr/>
          </p:nvSpPr>
          <p:spPr>
            <a:xfrm>
              <a:off x="2836800" y="898200"/>
              <a:ext cx="51991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0  0  0 .5  1  2  3   4  6  8  0  0  0  .5  1  2  3  4  6  8 Hr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987640" y="838080"/>
              <a:ext cx="22100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5349960" y="838080"/>
              <a:ext cx="22096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3134880" y="380880"/>
              <a:ext cx="3958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     </a:t>
              </a:r>
              <a:r>
                <a:rPr b="1" lang="en-US" sz="2000" spc="-1" strike="noStrike">
                  <a:solidFill>
                    <a:srgbClr val="000000"/>
                  </a:solidFill>
                  <a:latin typeface="Arial"/>
                </a:rPr>
                <a:t>Wild-type                 Hsf1-null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48" name="" descr=""/>
          <p:cNvPicPr/>
          <p:nvPr/>
        </p:nvPicPr>
        <p:blipFill>
          <a:blip r:embed="rId1"/>
          <a:stretch/>
        </p:blipFill>
        <p:spPr>
          <a:xfrm>
            <a:off x="2962440" y="1219320"/>
            <a:ext cx="4706640" cy="518148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2340720" y="304920"/>
            <a:ext cx="546480" cy="70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"/>
          <p:cNvSpPr/>
          <p:nvPr/>
        </p:nvSpPr>
        <p:spPr>
          <a:xfrm>
            <a:off x="1128600" y="-111240"/>
            <a:ext cx="1843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69640" y="0"/>
            <a:ext cx="1486800" cy="82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Additiona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File 11B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" name=""/>
          <p:cNvGrpSpPr/>
          <p:nvPr/>
        </p:nvGrpSpPr>
        <p:grpSpPr>
          <a:xfrm>
            <a:off x="2492280" y="457200"/>
            <a:ext cx="5695920" cy="6097680"/>
            <a:chOff x="2492280" y="457200"/>
            <a:chExt cx="5695920" cy="6097680"/>
          </a:xfrm>
        </p:grpSpPr>
        <p:grpSp>
          <p:nvGrpSpPr>
            <p:cNvPr id="53" name=""/>
            <p:cNvGrpSpPr/>
            <p:nvPr/>
          </p:nvGrpSpPr>
          <p:grpSpPr>
            <a:xfrm>
              <a:off x="2989080" y="533520"/>
              <a:ext cx="5199120" cy="854640"/>
              <a:chOff x="2989080" y="533520"/>
              <a:chExt cx="5199120" cy="854640"/>
            </a:xfrm>
          </p:grpSpPr>
          <p:sp>
            <p:nvSpPr>
              <p:cNvPr id="54" name=""/>
              <p:cNvSpPr/>
              <p:nvPr/>
            </p:nvSpPr>
            <p:spPr>
              <a:xfrm>
                <a:off x="2989080" y="1050840"/>
                <a:ext cx="51991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</a:rPr>
                  <a:t>0  0  0 .5  1  2  3   4  6  8  0  0  0  .5  1  2  3  4  6  8 Hrs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3139920" y="990720"/>
                <a:ext cx="221004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5502240" y="990720"/>
                <a:ext cx="220968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3287160" y="533520"/>
                <a:ext cx="395892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Arial"/>
                  </a:rPr>
                  <a:t>     </a:t>
                </a:r>
                <a:r>
                  <a:rPr b="1" lang="en-US" sz="2000" spc="-1" strike="noStrike">
                    <a:solidFill>
                      <a:srgbClr val="000000"/>
                    </a:solidFill>
                    <a:latin typeface="Arial"/>
                  </a:rPr>
                  <a:t>Wild-type                 Hsf1-null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8" name=""/>
            <p:cNvSpPr/>
            <p:nvPr/>
          </p:nvSpPr>
          <p:spPr>
            <a:xfrm>
              <a:off x="2492280" y="457200"/>
              <a:ext cx="519120" cy="703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4000" spc="-1" strike="noStrike">
                  <a:solidFill>
                    <a:srgbClr val="000000"/>
                  </a:solidFill>
                  <a:latin typeface="Times New Roman"/>
                </a:rPr>
                <a:t>B</a:t>
              </a:r>
              <a:endParaRPr b="0" lang="en-US" sz="4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9" name="" descr=""/>
            <p:cNvPicPr/>
            <p:nvPr/>
          </p:nvPicPr>
          <p:blipFill>
            <a:blip r:embed="rId1"/>
            <a:stretch/>
          </p:blipFill>
          <p:spPr>
            <a:xfrm>
              <a:off x="3124080" y="1371600"/>
              <a:ext cx="4707000" cy="518328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"/>
          <p:cNvSpPr/>
          <p:nvPr/>
        </p:nvSpPr>
        <p:spPr>
          <a:xfrm>
            <a:off x="1128600" y="-111240"/>
            <a:ext cx="1843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269640" y="0"/>
            <a:ext cx="1563120" cy="82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Additional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File 11C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2" name=""/>
          <p:cNvGrpSpPr/>
          <p:nvPr/>
        </p:nvGrpSpPr>
        <p:grpSpPr>
          <a:xfrm>
            <a:off x="2493000" y="457200"/>
            <a:ext cx="5695200" cy="6097680"/>
            <a:chOff x="2493000" y="457200"/>
            <a:chExt cx="5695200" cy="6097680"/>
          </a:xfrm>
        </p:grpSpPr>
        <p:grpSp>
          <p:nvGrpSpPr>
            <p:cNvPr id="63" name=""/>
            <p:cNvGrpSpPr/>
            <p:nvPr/>
          </p:nvGrpSpPr>
          <p:grpSpPr>
            <a:xfrm>
              <a:off x="2989080" y="533520"/>
              <a:ext cx="5199120" cy="854640"/>
              <a:chOff x="2989080" y="533520"/>
              <a:chExt cx="5199120" cy="854640"/>
            </a:xfrm>
          </p:grpSpPr>
          <p:sp>
            <p:nvSpPr>
              <p:cNvPr id="64" name=""/>
              <p:cNvSpPr/>
              <p:nvPr/>
            </p:nvSpPr>
            <p:spPr>
              <a:xfrm>
                <a:off x="2989080" y="1050840"/>
                <a:ext cx="51991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</a:rPr>
                  <a:t>0  0  0 .5  1  2  3   4  6  8  0  0  0  .5  1  2  3  4  6  8 Hrs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3139920" y="990720"/>
                <a:ext cx="221004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5502240" y="990720"/>
                <a:ext cx="220968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3287160" y="533520"/>
                <a:ext cx="395892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Arial"/>
                  </a:rPr>
                  <a:t>     </a:t>
                </a:r>
                <a:r>
                  <a:rPr b="1" lang="en-US" sz="2000" spc="-1" strike="noStrike">
                    <a:solidFill>
                      <a:srgbClr val="000000"/>
                    </a:solidFill>
                    <a:latin typeface="Arial"/>
                  </a:rPr>
                  <a:t>Wild-type                 Hsf1-null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8" name=""/>
            <p:cNvSpPr/>
            <p:nvPr/>
          </p:nvSpPr>
          <p:spPr>
            <a:xfrm>
              <a:off x="2493000" y="457200"/>
              <a:ext cx="546480" cy="703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4000" spc="-1" strike="noStrike">
                  <a:solidFill>
                    <a:srgbClr val="000000"/>
                  </a:solidFill>
                  <a:latin typeface="Times New Roman"/>
                </a:rPr>
                <a:t>C</a:t>
              </a:r>
              <a:endParaRPr b="0" lang="en-US" sz="4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9" name="" descr=""/>
            <p:cNvPicPr/>
            <p:nvPr/>
          </p:nvPicPr>
          <p:blipFill>
            <a:blip r:embed="rId1"/>
            <a:stretch/>
          </p:blipFill>
          <p:spPr>
            <a:xfrm>
              <a:off x="3124080" y="1371600"/>
              <a:ext cx="4707000" cy="518328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2-17T13:25:06Z</dcterms:created>
  <dc:creator>ctsuser</dc:creator>
  <dc:description/>
  <dc:language>en-US</dc:language>
  <cp:lastModifiedBy>Kate Mosford</cp:lastModifiedBy>
  <dcterms:modified xsi:type="dcterms:W3CDTF">2010-01-07T11:37:31Z</dcterms:modified>
  <cp:revision>2</cp:revision>
  <dc:subject/>
  <dc:title>Slide 1</dc:title>
</cp:coreProperties>
</file>